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1" autoAdjust="0"/>
    <p:restoredTop sz="94660"/>
  </p:normalViewPr>
  <p:slideViewPr>
    <p:cSldViewPr snapToGrid="0">
      <p:cViewPr varScale="1">
        <p:scale>
          <a:sx n="77" d="100"/>
          <a:sy n="77" d="100"/>
        </p:scale>
        <p:origin x="1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81C87C-30E6-4D81-BEA4-67A4140BD6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6EAEA2-0F35-4357-9081-4498CDCF3D3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52BF85-9A34-485E-B402-33FBF299B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02302-DC7C-48A7-8379-4732EB1F8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7E13BD-AE56-41A5-BE05-40DE4AC2F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7592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22EFCF-92BD-45C5-859C-4DF68B1839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3A4C1A-8549-4794-995A-F5023B8D9E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478B2-AE84-42D9-B478-D366A2669E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08FDF-8358-4F42-9CF8-D67A2FDBD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4B3F71-1068-4FED-9AA8-DF5BDD411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7730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BD0BA40-C696-43F6-B540-7761ADF722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1A1A0B-86F4-477B-BB4C-4BBE2D49F1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277463-015E-4A42-955E-E389A6D99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3AB90E-569E-4217-87B5-E3AEB64B43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F29B20-47E2-455C-A2FC-81F17B9197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668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498E6-8B59-4056-9894-305BB380E2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CB077F-322E-403F-84E6-B9ACE8B694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15C570-9116-49F9-B143-0D558267F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34CE7B-8693-4070-B5EF-D92CEB976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414038-D58C-4F8D-B83C-D7CB22A2ED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8450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5B78-9ED1-4472-AF4B-6FA2885DF1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23CE3B-5963-4A3E-8442-777CD46726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91A521-5AD6-43BF-87E1-260C8912D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D4F8B7-C9F8-4C72-A351-F5F5684D1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DDE90-9DA7-45CE-B8B9-02B06504E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716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20E91-57C8-44A1-B5E8-EEF23931E3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14AF7C-6BA5-4CE5-BE46-F0A5890D75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337D9F-FE03-48F2-86D3-C9CA03827F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6D8BE3-DEE2-497C-A38E-1B2C5FAC8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59B930-CE90-4BB3-B9A8-52CB9833A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B0B048-44EF-458C-9986-0F0DEDFDD2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8740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BD1216-9AB9-4BAE-B36A-EE3DC0A103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E7DAB9-83FD-48E2-99C7-D7D6FC4400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70F1B9C-D44B-4C99-A841-99893605FE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45A042-3FB3-4F3A-92BB-CBCD04D14A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697070-710E-4D2D-AD27-1DC7CDB378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C35D50-43A9-4F7F-B2D9-D61733B0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D34E9B-EA94-4B47-9FF1-256DAAE13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A0C485-71ED-411C-9A4C-F79F17ED9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1188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0BEEA-DAEA-478B-8AC8-6F645F4FDF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D4C594-9288-4150-85A6-14B543163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42A9E8-BC4C-44AD-98CC-5A2383D0C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2328EC-6DE8-4221-A0CB-956DE34C52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972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E94AB0-2761-42C3-B4D2-975F3B2FE8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4F2B97-7D04-4DE9-8619-58DF7AA85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89CDC8-8914-4924-86CD-C2B68A3D0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6464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04C21-CB61-42DA-8018-0ECD38CB07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75FBA9-BB00-4D14-91FA-AD94DA589B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6A04B4-2870-42D0-ABC2-0C5AC38D6C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53C894-ECF7-45C8-B316-D2A8AAB72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1CD64A-0893-4F4E-93C5-2EE2FB21A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729C40-1BCF-4DCF-9D7F-1860AB591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5313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72D64-3595-49D7-A0EC-EB19C51B3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B8FB9C-F584-457E-8F6F-E204A22176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AE5F8E-0B41-41FB-87B1-A591BE3E66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7F16EF-3C6B-40E9-9CF8-61F557062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CBEFC3-2229-4030-9C8A-035FA1EC0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3D11A8-00FC-4F96-A113-41906C0994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6571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C16FEA-3F11-4F19-9A6C-DBEEEE919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45AC03-2C44-4A1E-BE56-638EA0A9F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DD1AB9-319F-4EB7-A517-2F6218CB16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2BAFE6-79BD-4C7B-BC3C-D413FAD8D154}" type="datetimeFigureOut">
              <a:rPr lang="en-GB" smtClean="0"/>
              <a:t>14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3D23AF-D5E5-4E48-98F3-1844DC2D80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1341E-D522-4839-B6C7-CE9614A258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1FB29-259D-481F-8CEF-A4FD914E2B3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778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ymail_attachmentIdcc60ede7-1a02-4650-93a8-20a0e003e9da">
            <a:extLst>
              <a:ext uri="{FF2B5EF4-FFF2-40B4-BE49-F238E27FC236}">
                <a16:creationId xmlns:a16="http://schemas.microsoft.com/office/drawing/2014/main" id="{3DFC0BFF-4565-4BF5-B65E-581DBC24BF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965395" y="447886"/>
            <a:ext cx="7428089" cy="5571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0EC3BA1-5F31-48B0-A89E-A19996C3239F}"/>
              </a:ext>
            </a:extLst>
          </p:cNvPr>
          <p:cNvSpPr txBox="1"/>
          <p:nvPr/>
        </p:nvSpPr>
        <p:spPr>
          <a:xfrm>
            <a:off x="1669935" y="6271614"/>
            <a:ext cx="8105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S15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light test devices (version 1.0) running with pink-colored vs white/transparent flight tubes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9675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GA, Hamidou</dc:creator>
  <cp:lastModifiedBy>MAIGA H</cp:lastModifiedBy>
  <cp:revision>5</cp:revision>
  <dcterms:created xsi:type="dcterms:W3CDTF">2022-01-25T10:43:57Z</dcterms:created>
  <dcterms:modified xsi:type="dcterms:W3CDTF">2022-02-14T15:59:57Z</dcterms:modified>
</cp:coreProperties>
</file>